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78"/>
    <p:restoredTop sz="94607"/>
  </p:normalViewPr>
  <p:slideViewPr>
    <p:cSldViewPr snapToGrid="0">
      <p:cViewPr varScale="1">
        <p:scale>
          <a:sx n="130" d="100"/>
          <a:sy n="130" d="100"/>
        </p:scale>
        <p:origin x="224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93C653-8388-4927-ADEE-C5507B7AC4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B13F1A-D300-9752-4B72-2E761D9DB9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6FF15B-C576-7270-8BD9-D8C11F7EB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3964D-979C-555A-A85E-FBFF6ECA2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A64807-013B-3FAC-3964-620ACE07A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568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29BE4-BD7A-5759-FA7C-3F270187C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61E5A8-D44B-EFCC-AAD0-D0E0A6DC94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F04B9-B98B-8E4B-764D-7C4AD6AD4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1967B-4B5B-E513-3905-5A3A7887A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8B36B1-1DF8-0327-B5F4-C15EFAA9A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318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95D624-6447-4B77-50EC-5274E0CC94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5B8518-A4E3-5A14-DAF7-1A7C3202A7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7418F-314A-D1B7-63D7-74695C5D5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F9FF23-4A87-02DD-F649-474ECF29A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16105-AE4E-ACD1-E2C1-2D8C5D10D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56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EDBBD-65A3-BC44-E6BB-19D4CA666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6310A4-37FB-568C-881D-1D74AF70C3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30766B-197B-528C-BF26-BE7D2EC02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70D51A-E23A-56F6-404A-FFD026478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9CC190-5553-CB51-80E3-0EF53C58C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801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A7B51-03AE-2F38-5011-CA32E911B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DC76F2-8DEB-70F9-F3EB-9EB2CD7FD9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281C5-A694-512C-53ED-40B9A6D89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70FDF-EAD5-C8C7-E412-6AF3271B7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021CAB-0979-0C16-B67F-BE23E9D4E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299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AE51A-8BC6-966E-7AAD-D52A0911A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4FAFF5-A733-14EF-555D-DFBD55B20D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47603D-6F14-632D-DEDE-E8B1E096E7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D4695F-C935-7BB0-6067-90D6741BD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3F1052-F7A6-3555-622D-8FDCD0AA8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CC93C8-3426-65BA-5632-79635DF85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23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A38CD-C816-858E-7B49-12C619321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DDCB90-3643-6134-3F50-8E95799BA2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12A07D-C2E7-6622-7659-31B52BDF40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8724D4-DE56-F79A-F9E3-DC7570D4B8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867E09-CC4D-8592-0A2D-7B25B74E54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9507B6-069A-0D7B-1711-51795ABC6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1A2875-B4DA-46A5-6ED9-9D36A4D36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4E3899-A7C8-2077-52EF-B3A9387EB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147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A96BC-590B-4037-8A1A-B60B09263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284571-B6C9-E969-6282-8F5F57975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FB7CA1E-2715-352F-A0EE-7C15FBFF2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59B0F7-26CD-7166-90D9-E1B115479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751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17177BC-1491-CAE9-5AFF-0B77C518C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53C5A2-7510-9FDD-56FB-F180C8174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8C99C36-294E-7FFA-EE7E-D65FBD622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063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92AEFB-1A99-B480-B57E-241A77788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3C8E20-A9A8-C954-8E15-CD0BF43824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CF6068-8F3B-D5CD-5A01-EDB4EBF1C0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6B587D-C91C-4212-6DC1-866F8C272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85E63E-409C-7B22-8C43-5F81A9DA6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46AD36-FAB6-81A4-9656-A81273A5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459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C126F-8C8D-8EC2-022A-E9978251E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8CF876-F7CA-9522-BC19-F137E1B9B7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D82A99-0B67-DC44-1397-3E7776DDF4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85FBC-DF63-B70F-E71F-28880E5AC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C08A95-698D-7C31-C27A-690344AF8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8818E2-2C83-2E4D-EC43-705D0B960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333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D38876-4771-3D49-D9F9-F1B5F5AB9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B78EF7-9C88-D244-543A-5A64912D35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20C2BC-A97C-4834-77BF-66D014B3D4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E201B0-DA65-7046-BDC3-A733654D37D0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D69AF7-13D0-40EF-522C-EFB96EE319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B9B45A-C584-35F7-C4CF-64D40CC590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144710-AF5A-5E43-AD3A-F28C800B1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47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Venn-Diagram">
            <a:extLst>
              <a:ext uri="{FF2B5EF4-FFF2-40B4-BE49-F238E27FC236}">
                <a16:creationId xmlns:a16="http://schemas.microsoft.com/office/drawing/2014/main" id="{9EDD1C79-7DED-B132-EBA8-6A02727A9D0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29" r="12214"/>
          <a:stretch/>
        </p:blipFill>
        <p:spPr bwMode="auto">
          <a:xfrm>
            <a:off x="267374" y="530941"/>
            <a:ext cx="5572987" cy="56101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5D90715-B413-D231-C0C7-443F8D47A808}"/>
              </a:ext>
            </a:extLst>
          </p:cNvPr>
          <p:cNvSpPr txBox="1"/>
          <p:nvPr/>
        </p:nvSpPr>
        <p:spPr>
          <a:xfrm>
            <a:off x="5840361" y="4295734"/>
            <a:ext cx="590049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Venn diagram of shared and unique genes in MSU001 and the clinically important </a:t>
            </a:r>
            <a:r>
              <a:rPr lang="en-US" sz="1800" b="1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izabethkinig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unique and shared genome among the compared genomes were determined using the BLAST score ratio approach of EDGAR 3.2 with a cutoff of 30%. 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4422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4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icheng Chen</dc:creator>
  <cp:lastModifiedBy>Shicheng Chen</cp:lastModifiedBy>
  <cp:revision>1</cp:revision>
  <dcterms:created xsi:type="dcterms:W3CDTF">2024-05-16T21:03:22Z</dcterms:created>
  <dcterms:modified xsi:type="dcterms:W3CDTF">2024-05-16T21:08:13Z</dcterms:modified>
</cp:coreProperties>
</file>